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2C7639-141A-477D-8CB5-B69DD9C9310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58495E-3318-4835-9903-C8A9513BDE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B8C8E7-02E6-4BD4-8AD6-437B6C3168D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261BC1-053A-4D4A-857D-90EA02B807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F150EA-6D0D-42E4-B2B0-B611D39FAC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BC115C-362F-4679-BB9D-3212C77947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BDCA85-AB41-433A-AFF5-5096DD8931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7CE916-2049-4C82-ABBB-2602ABB5FB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828ACB-0788-421D-B7C2-1D8A8102AA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BED30A-DC38-46AF-8A5D-B6036F7804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FB59EA-FC40-410A-9C52-FB5934A460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30DB1D-DF2B-4F2A-B992-7613054BE7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2F645C-1A1F-48E3-AD1B-350F26DDF748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429000" y="2346480"/>
            <a:ext cx="806400" cy="882360"/>
            <a:chOff x="3429000" y="2346480"/>
            <a:chExt cx="806400" cy="882360"/>
          </a:xfrm>
        </p:grpSpPr>
        <p:sp>
          <p:nvSpPr>
            <p:cNvPr id="42" name=""/>
            <p:cNvSpPr/>
            <p:nvPr/>
          </p:nvSpPr>
          <p:spPr>
            <a:xfrm>
              <a:off x="3429000" y="2346480"/>
              <a:ext cx="272880" cy="2728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3519360" y="2436840"/>
              <a:ext cx="90720" cy="903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7640" bIns="176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44" name=""/>
            <p:cNvGrpSpPr/>
            <p:nvPr/>
          </p:nvGrpSpPr>
          <p:grpSpPr>
            <a:xfrm>
              <a:off x="3962520" y="2346480"/>
              <a:ext cx="272880" cy="272880"/>
              <a:chOff x="3962520" y="2346480"/>
              <a:chExt cx="272880" cy="272880"/>
            </a:xfrm>
          </p:grpSpPr>
          <p:sp>
            <p:nvSpPr>
              <p:cNvPr id="45" name=""/>
              <p:cNvSpPr/>
              <p:nvPr/>
            </p:nvSpPr>
            <p:spPr>
              <a:xfrm>
                <a:off x="3962520" y="2346480"/>
                <a:ext cx="272880" cy="27288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4052880" y="2438640"/>
                <a:ext cx="90000" cy="903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7640" bIns="1764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47" name=""/>
            <p:cNvSpPr/>
            <p:nvPr/>
          </p:nvSpPr>
          <p:spPr>
            <a:xfrm>
              <a:off x="3706920" y="2498760"/>
              <a:ext cx="252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835440" y="2498760"/>
              <a:ext cx="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699000" y="2955960"/>
              <a:ext cx="272880" cy="2728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0" name=""/>
          <p:cNvSpPr/>
          <p:nvPr/>
        </p:nvSpPr>
        <p:spPr>
          <a:xfrm>
            <a:off x="2895480" y="2041560"/>
            <a:ext cx="198720" cy="152388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51" name=""/>
          <p:cNvGrpSpPr/>
          <p:nvPr/>
        </p:nvGrpSpPr>
        <p:grpSpPr>
          <a:xfrm>
            <a:off x="2133720" y="2041560"/>
            <a:ext cx="914400" cy="1236960"/>
            <a:chOff x="2133720" y="2041560"/>
            <a:chExt cx="914400" cy="1236960"/>
          </a:xfrm>
        </p:grpSpPr>
        <p:sp>
          <p:nvSpPr>
            <p:cNvPr id="52" name=""/>
            <p:cNvSpPr/>
            <p:nvPr/>
          </p:nvSpPr>
          <p:spPr>
            <a:xfrm>
              <a:off x="2438640" y="2041560"/>
              <a:ext cx="198360" cy="982800"/>
            </a:xfrm>
            <a:prstGeom prst="rect">
              <a:avLst/>
            </a:prstGeom>
            <a:solidFill>
              <a:srgbClr val="dddddd"/>
            </a:solidFill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53" name=""/>
            <p:cNvGrpSpPr/>
            <p:nvPr/>
          </p:nvGrpSpPr>
          <p:grpSpPr>
            <a:xfrm>
              <a:off x="2133720" y="2041560"/>
              <a:ext cx="914400" cy="1236960"/>
              <a:chOff x="2133720" y="2041560"/>
              <a:chExt cx="914400" cy="1236960"/>
            </a:xfrm>
          </p:grpSpPr>
          <p:grpSp>
            <p:nvGrpSpPr>
              <p:cNvPr id="54" name=""/>
              <p:cNvGrpSpPr/>
              <p:nvPr/>
            </p:nvGrpSpPr>
            <p:grpSpPr>
              <a:xfrm>
                <a:off x="2362320" y="2041560"/>
                <a:ext cx="685800" cy="977760"/>
                <a:chOff x="2362320" y="2041560"/>
                <a:chExt cx="685800" cy="977760"/>
              </a:xfrm>
            </p:grpSpPr>
            <p:sp>
              <p:nvSpPr>
                <p:cNvPr id="55" name=""/>
                <p:cNvSpPr/>
                <p:nvPr/>
              </p:nvSpPr>
              <p:spPr>
                <a:xfrm>
                  <a:off x="2438640" y="2041560"/>
                  <a:ext cx="0" cy="9144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6" name=""/>
                <p:cNvSpPr/>
                <p:nvPr/>
              </p:nvSpPr>
              <p:spPr>
                <a:xfrm>
                  <a:off x="2362320" y="2041560"/>
                  <a:ext cx="6858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12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7" name=""/>
                <p:cNvSpPr/>
                <p:nvPr/>
              </p:nvSpPr>
              <p:spPr>
                <a:xfrm>
                  <a:off x="2362320" y="2193840"/>
                  <a:ext cx="6858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64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8" name=""/>
                <p:cNvSpPr/>
                <p:nvPr/>
              </p:nvSpPr>
              <p:spPr>
                <a:xfrm>
                  <a:off x="2362320" y="2346480"/>
                  <a:ext cx="6858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63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9" name=""/>
                <p:cNvSpPr/>
                <p:nvPr/>
              </p:nvSpPr>
              <p:spPr>
                <a:xfrm>
                  <a:off x="2362320" y="2498760"/>
                  <a:ext cx="6858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5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0" name=""/>
                <p:cNvSpPr/>
                <p:nvPr/>
              </p:nvSpPr>
              <p:spPr>
                <a:xfrm>
                  <a:off x="2362320" y="2651040"/>
                  <a:ext cx="6858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91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1" name=""/>
                <p:cNvSpPr/>
                <p:nvPr/>
              </p:nvSpPr>
              <p:spPr>
                <a:xfrm>
                  <a:off x="2362320" y="2803680"/>
                  <a:ext cx="6858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60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sp>
            <p:nvSpPr>
              <p:cNvPr id="62" name=""/>
              <p:cNvSpPr/>
              <p:nvPr/>
            </p:nvSpPr>
            <p:spPr>
              <a:xfrm>
                <a:off x="2210040" y="3032280"/>
                <a:ext cx="533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BB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2133720" y="204156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21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2133720" y="219384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16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2133720" y="234648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</a:rPr>
                  <a:t>17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133720" y="249876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</a:rPr>
                  <a:t>107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2133720" y="265104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</a:rPr>
                  <a:t>8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2133720" y="280368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25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grpSp>
        <p:nvGrpSpPr>
          <p:cNvPr id="69" name=""/>
          <p:cNvGrpSpPr/>
          <p:nvPr/>
        </p:nvGrpSpPr>
        <p:grpSpPr>
          <a:xfrm>
            <a:off x="2819520" y="2041560"/>
            <a:ext cx="685800" cy="1587240"/>
            <a:chOff x="2819520" y="2041560"/>
            <a:chExt cx="685800" cy="1587240"/>
          </a:xfrm>
        </p:grpSpPr>
        <p:sp>
          <p:nvSpPr>
            <p:cNvPr id="70" name=""/>
            <p:cNvSpPr/>
            <p:nvPr/>
          </p:nvSpPr>
          <p:spPr>
            <a:xfrm>
              <a:off x="2819520" y="204156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3333cc"/>
                  </a:solidFill>
                  <a:latin typeface="Arial"/>
                </a:rPr>
                <a:t>17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819520" y="219384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3333cc"/>
                  </a:solidFill>
                  <a:latin typeface="Arial"/>
                </a:rPr>
                <a:t>15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819520" y="234648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3333cc"/>
                  </a:solidFill>
                  <a:latin typeface="Arial"/>
                </a:rPr>
                <a:t>14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819520" y="249876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3333cc"/>
                  </a:solidFill>
                  <a:latin typeface="Arial"/>
                </a:rPr>
                <a:t>168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819520" y="265104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3333cc"/>
                  </a:solidFill>
                  <a:latin typeface="Arial"/>
                </a:rPr>
                <a:t>23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819520" y="280368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3333cc"/>
                  </a:solidFill>
                  <a:latin typeface="Arial"/>
                </a:rPr>
                <a:t>17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819520" y="295596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3333cc"/>
                  </a:solidFill>
                  <a:latin typeface="Arial"/>
                </a:rPr>
                <a:t>13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819520" y="310824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3333cc"/>
                  </a:solidFill>
                  <a:latin typeface="Arial"/>
                </a:rPr>
                <a:t>22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819520" y="326088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3333cc"/>
                  </a:solidFill>
                  <a:latin typeface="Arial"/>
                </a:rPr>
                <a:t>14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819520" y="341316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3333cc"/>
                  </a:solidFill>
                  <a:latin typeface="Arial"/>
                </a:rPr>
                <a:t>16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895840" y="2041560"/>
              <a:ext cx="0" cy="1523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1" name=""/>
          <p:cNvSpPr/>
          <p:nvPr/>
        </p:nvSpPr>
        <p:spPr>
          <a:xfrm>
            <a:off x="2666880" y="36417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L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2" name=""/>
          <p:cNvGrpSpPr/>
          <p:nvPr/>
        </p:nvGrpSpPr>
        <p:grpSpPr>
          <a:xfrm>
            <a:off x="2590920" y="2041560"/>
            <a:ext cx="685800" cy="1587240"/>
            <a:chOff x="2590920" y="2041560"/>
            <a:chExt cx="685800" cy="1587240"/>
          </a:xfrm>
        </p:grpSpPr>
        <p:sp>
          <p:nvSpPr>
            <p:cNvPr id="83" name=""/>
            <p:cNvSpPr/>
            <p:nvPr/>
          </p:nvSpPr>
          <p:spPr>
            <a:xfrm>
              <a:off x="2590920" y="204156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9999"/>
                  </a:solidFill>
                  <a:latin typeface="Arial"/>
                </a:rPr>
                <a:t>17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590920" y="219384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9999"/>
                  </a:solidFill>
                  <a:latin typeface="Arial"/>
                </a:rPr>
                <a:t>15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590920" y="234648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9999"/>
                  </a:solidFill>
                  <a:latin typeface="Arial"/>
                </a:rPr>
                <a:t>14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590920" y="249876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9999"/>
                  </a:solidFill>
                  <a:latin typeface="Arial"/>
                </a:rPr>
                <a:t>18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590920" y="265104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9999"/>
                  </a:solidFill>
                  <a:latin typeface="Arial"/>
                </a:rPr>
                <a:t>23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590920" y="280368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9999"/>
                  </a:solidFill>
                  <a:latin typeface="Arial"/>
                </a:rPr>
                <a:t>17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590920" y="295596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9999"/>
                  </a:solidFill>
                  <a:latin typeface="Arial"/>
                </a:rPr>
                <a:t>13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2590920" y="310824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9999"/>
                  </a:solidFill>
                  <a:latin typeface="Arial"/>
                </a:rPr>
                <a:t>22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590920" y="326088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9999"/>
                  </a:solidFill>
                  <a:latin typeface="Arial"/>
                </a:rPr>
                <a:t>13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590920" y="341316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9999"/>
                  </a:solidFill>
                  <a:latin typeface="Arial"/>
                </a:rPr>
                <a:t>16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93" name=""/>
          <p:cNvGrpSpPr/>
          <p:nvPr/>
        </p:nvGrpSpPr>
        <p:grpSpPr>
          <a:xfrm>
            <a:off x="4419720" y="2041560"/>
            <a:ext cx="914400" cy="1236960"/>
            <a:chOff x="4419720" y="2041560"/>
            <a:chExt cx="914400" cy="1236960"/>
          </a:xfrm>
        </p:grpSpPr>
        <p:sp>
          <p:nvSpPr>
            <p:cNvPr id="94" name=""/>
            <p:cNvSpPr/>
            <p:nvPr/>
          </p:nvSpPr>
          <p:spPr>
            <a:xfrm>
              <a:off x="4724280" y="2041560"/>
              <a:ext cx="198720" cy="990720"/>
            </a:xfrm>
            <a:prstGeom prst="rect">
              <a:avLst/>
            </a:prstGeom>
            <a:solidFill>
              <a:srgbClr val="dddddd"/>
            </a:solidFill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95" name=""/>
            <p:cNvGrpSpPr/>
            <p:nvPr/>
          </p:nvGrpSpPr>
          <p:grpSpPr>
            <a:xfrm>
              <a:off x="4419720" y="2041560"/>
              <a:ext cx="914400" cy="1236960"/>
              <a:chOff x="4419720" y="2041560"/>
              <a:chExt cx="914400" cy="1236960"/>
            </a:xfrm>
          </p:grpSpPr>
          <p:grpSp>
            <p:nvGrpSpPr>
              <p:cNvPr id="96" name=""/>
              <p:cNvGrpSpPr/>
              <p:nvPr/>
            </p:nvGrpSpPr>
            <p:grpSpPr>
              <a:xfrm>
                <a:off x="4648320" y="2041560"/>
                <a:ext cx="685800" cy="977760"/>
                <a:chOff x="4648320" y="2041560"/>
                <a:chExt cx="685800" cy="977760"/>
              </a:xfrm>
            </p:grpSpPr>
            <p:sp>
              <p:nvSpPr>
                <p:cNvPr id="97" name=""/>
                <p:cNvSpPr/>
                <p:nvPr/>
              </p:nvSpPr>
              <p:spPr>
                <a:xfrm>
                  <a:off x="4724640" y="2041560"/>
                  <a:ext cx="0" cy="9144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8" name=""/>
                <p:cNvSpPr/>
                <p:nvPr/>
              </p:nvSpPr>
              <p:spPr>
                <a:xfrm>
                  <a:off x="4648320" y="2041560"/>
                  <a:ext cx="6858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02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9" name=""/>
                <p:cNvSpPr/>
                <p:nvPr/>
              </p:nvSpPr>
              <p:spPr>
                <a:xfrm>
                  <a:off x="4648320" y="2193840"/>
                  <a:ext cx="6858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60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00" name=""/>
                <p:cNvSpPr/>
                <p:nvPr/>
              </p:nvSpPr>
              <p:spPr>
                <a:xfrm>
                  <a:off x="4648320" y="2346480"/>
                  <a:ext cx="6858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67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01" name=""/>
                <p:cNvSpPr/>
                <p:nvPr/>
              </p:nvSpPr>
              <p:spPr>
                <a:xfrm>
                  <a:off x="4648320" y="2498760"/>
                  <a:ext cx="6858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7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02" name=""/>
                <p:cNvSpPr/>
                <p:nvPr/>
              </p:nvSpPr>
              <p:spPr>
                <a:xfrm>
                  <a:off x="4648320" y="2651040"/>
                  <a:ext cx="6858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83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03" name=""/>
                <p:cNvSpPr/>
                <p:nvPr/>
              </p:nvSpPr>
              <p:spPr>
                <a:xfrm>
                  <a:off x="4648320" y="2803680"/>
                  <a:ext cx="6858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58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sp>
            <p:nvSpPr>
              <p:cNvPr id="104" name=""/>
              <p:cNvSpPr/>
              <p:nvPr/>
            </p:nvSpPr>
            <p:spPr>
              <a:xfrm>
                <a:off x="4496040" y="3032280"/>
                <a:ext cx="533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BB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4419720" y="204156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20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4419720" y="219384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1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4419720" y="234648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</a:rPr>
                  <a:t>16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4419720" y="249876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</a:rPr>
                  <a:t>10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4419720" y="265104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</a:rPr>
                  <a:t>8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4419720" y="280368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25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sp>
        <p:nvSpPr>
          <p:cNvPr id="111" name=""/>
          <p:cNvSpPr/>
          <p:nvPr/>
        </p:nvSpPr>
        <p:spPr>
          <a:xfrm>
            <a:off x="5181480" y="2041560"/>
            <a:ext cx="198720" cy="152388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12" name=""/>
          <p:cNvGrpSpPr/>
          <p:nvPr/>
        </p:nvGrpSpPr>
        <p:grpSpPr>
          <a:xfrm>
            <a:off x="5105520" y="2041560"/>
            <a:ext cx="685800" cy="1587240"/>
            <a:chOff x="5105520" y="2041560"/>
            <a:chExt cx="685800" cy="1587240"/>
          </a:xfrm>
        </p:grpSpPr>
        <p:sp>
          <p:nvSpPr>
            <p:cNvPr id="113" name=""/>
            <p:cNvSpPr/>
            <p:nvPr/>
          </p:nvSpPr>
          <p:spPr>
            <a:xfrm>
              <a:off x="5105520" y="204156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ff3300"/>
                  </a:solidFill>
                  <a:latin typeface="Arial"/>
                </a:rPr>
                <a:t>16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5105520" y="219384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ff3300"/>
                  </a:solidFill>
                  <a:latin typeface="Arial"/>
                </a:rPr>
                <a:t>15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5105520" y="234648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ff3300"/>
                  </a:solidFill>
                  <a:latin typeface="Arial"/>
                </a:rPr>
                <a:t>144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5105520" y="249876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ff3300"/>
                  </a:solidFill>
                  <a:latin typeface="Arial"/>
                </a:rPr>
                <a:t>1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5105520" y="265104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ff3300"/>
                  </a:solidFill>
                  <a:latin typeface="Arial"/>
                </a:rPr>
                <a:t>23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5105520" y="280368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ff3300"/>
                  </a:solidFill>
                  <a:latin typeface="Arial"/>
                </a:rPr>
                <a:t>184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5105520" y="295596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ff3300"/>
                  </a:solidFill>
                  <a:latin typeface="Arial"/>
                </a:rPr>
                <a:t>13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5105520" y="310824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ff3300"/>
                  </a:solidFill>
                  <a:latin typeface="Arial"/>
                </a:rPr>
                <a:t>22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5105520" y="326088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ff3300"/>
                  </a:solidFill>
                  <a:latin typeface="Arial"/>
                </a:rPr>
                <a:t>13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5105520" y="341316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ff3300"/>
                  </a:solidFill>
                  <a:latin typeface="Arial"/>
                </a:rPr>
                <a:t>16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5181840" y="2041560"/>
              <a:ext cx="0" cy="1523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24" name=""/>
          <p:cNvGrpSpPr/>
          <p:nvPr/>
        </p:nvGrpSpPr>
        <p:grpSpPr>
          <a:xfrm>
            <a:off x="4876920" y="2041560"/>
            <a:ext cx="685800" cy="1846440"/>
            <a:chOff x="4876920" y="2041560"/>
            <a:chExt cx="685800" cy="1846440"/>
          </a:xfrm>
        </p:grpSpPr>
        <p:sp>
          <p:nvSpPr>
            <p:cNvPr id="125" name=""/>
            <p:cNvSpPr/>
            <p:nvPr/>
          </p:nvSpPr>
          <p:spPr>
            <a:xfrm>
              <a:off x="4953240" y="3641760"/>
              <a:ext cx="457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9900"/>
                  </a:solidFill>
                  <a:latin typeface="Arial"/>
                </a:rPr>
                <a:t>HL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26" name=""/>
            <p:cNvGrpSpPr/>
            <p:nvPr/>
          </p:nvGrpSpPr>
          <p:grpSpPr>
            <a:xfrm>
              <a:off x="4876920" y="2041560"/>
              <a:ext cx="685800" cy="1587240"/>
              <a:chOff x="4876920" y="2041560"/>
              <a:chExt cx="685800" cy="1587240"/>
            </a:xfrm>
          </p:grpSpPr>
          <p:sp>
            <p:nvSpPr>
              <p:cNvPr id="127" name=""/>
              <p:cNvSpPr/>
              <p:nvPr/>
            </p:nvSpPr>
            <p:spPr>
              <a:xfrm>
                <a:off x="4876920" y="204156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ff9900"/>
                    </a:solidFill>
                    <a:latin typeface="Arial"/>
                  </a:rPr>
                  <a:t>17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4876920" y="219384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ff9900"/>
                    </a:solidFill>
                    <a:latin typeface="Arial"/>
                  </a:rPr>
                  <a:t>15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4876920" y="234648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ff9900"/>
                    </a:solidFill>
                    <a:latin typeface="Arial"/>
                  </a:rPr>
                  <a:t>14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4876920" y="249876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ff9900"/>
                    </a:solidFill>
                    <a:latin typeface="Arial"/>
                  </a:rPr>
                  <a:t>19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4876920" y="265104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ff9900"/>
                    </a:solidFill>
                    <a:latin typeface="Arial"/>
                  </a:rPr>
                  <a:t>23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4876920" y="280368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ff9900"/>
                    </a:solidFill>
                    <a:latin typeface="Arial"/>
                  </a:rPr>
                  <a:t>19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4876920" y="295596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ff9900"/>
                    </a:solidFill>
                    <a:latin typeface="Arial"/>
                  </a:rPr>
                  <a:t>13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4876920" y="310824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ff9900"/>
                    </a:solidFill>
                    <a:latin typeface="Arial"/>
                  </a:rPr>
                  <a:t>22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4876920" y="326088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ff9900"/>
                    </a:solidFill>
                    <a:latin typeface="Arial"/>
                  </a:rPr>
                  <a:t>13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4876920" y="341316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ff9900"/>
                    </a:solidFill>
                    <a:latin typeface="Arial"/>
                  </a:rPr>
                  <a:t>16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sp>
        <p:nvSpPr>
          <p:cNvPr id="137" name=""/>
          <p:cNvSpPr/>
          <p:nvPr/>
        </p:nvSpPr>
        <p:spPr>
          <a:xfrm>
            <a:off x="3392640" y="3336840"/>
            <a:ext cx="198360" cy="990720"/>
          </a:xfrm>
          <a:prstGeom prst="rect">
            <a:avLst/>
          </a:prstGeom>
          <a:solidFill>
            <a:srgbClr val="dddddd"/>
          </a:solidFill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3600360" y="3336840"/>
            <a:ext cx="198360" cy="990720"/>
          </a:xfrm>
          <a:prstGeom prst="rect">
            <a:avLst/>
          </a:prstGeom>
          <a:solidFill>
            <a:srgbClr val="dddddd"/>
          </a:solidFill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39" name=""/>
          <p:cNvGrpSpPr/>
          <p:nvPr/>
        </p:nvGrpSpPr>
        <p:grpSpPr>
          <a:xfrm>
            <a:off x="3524400" y="3336840"/>
            <a:ext cx="685800" cy="977760"/>
            <a:chOff x="3524400" y="3336840"/>
            <a:chExt cx="685800" cy="977760"/>
          </a:xfrm>
        </p:grpSpPr>
        <p:sp>
          <p:nvSpPr>
            <p:cNvPr id="140" name=""/>
            <p:cNvSpPr/>
            <p:nvPr/>
          </p:nvSpPr>
          <p:spPr>
            <a:xfrm>
              <a:off x="3600720" y="3336840"/>
              <a:ext cx="0" cy="914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3524400" y="333684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20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3524400" y="348912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1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3524400" y="364176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</a:rPr>
                <a:t>16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3524400" y="379404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</a:rPr>
                <a:t>10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3524400" y="394632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</a:rPr>
                <a:t>8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3524400" y="409896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258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47" name=""/>
          <p:cNvSpPr/>
          <p:nvPr/>
        </p:nvSpPr>
        <p:spPr>
          <a:xfrm>
            <a:off x="3371760" y="432756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BB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>
            <a:off x="3295800" y="333684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21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>
            <a:off x="3295800" y="348948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16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>
            <a:off x="3295800" y="364176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Arial"/>
              </a:rPr>
              <a:t>16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3295800" y="379404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Arial"/>
              </a:rPr>
              <a:t>10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>
            <a:off x="3295800" y="394668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Arial"/>
              </a:rPr>
              <a:t>9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>
            <a:off x="3295800" y="409896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26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4057560" y="3336840"/>
            <a:ext cx="198360" cy="152424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>
            <a:off x="3859200" y="3336840"/>
            <a:ext cx="198360" cy="152424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56" name=""/>
          <p:cNvGrpSpPr/>
          <p:nvPr/>
        </p:nvGrpSpPr>
        <p:grpSpPr>
          <a:xfrm>
            <a:off x="3981600" y="3336840"/>
            <a:ext cx="685800" cy="1587240"/>
            <a:chOff x="3981600" y="3336840"/>
            <a:chExt cx="685800" cy="1587240"/>
          </a:xfrm>
        </p:grpSpPr>
        <p:sp>
          <p:nvSpPr>
            <p:cNvPr id="157" name=""/>
            <p:cNvSpPr/>
            <p:nvPr/>
          </p:nvSpPr>
          <p:spPr>
            <a:xfrm>
              <a:off x="3981600" y="333684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ff3300"/>
                  </a:solidFill>
                  <a:latin typeface="Arial"/>
                </a:rPr>
                <a:t>16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3981600" y="348912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ff3300"/>
                  </a:solidFill>
                  <a:latin typeface="Arial"/>
                </a:rPr>
                <a:t>15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3981600" y="364176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ff3300"/>
                  </a:solidFill>
                  <a:latin typeface="Arial"/>
                </a:rPr>
                <a:t>144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3981600" y="379404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ff3300"/>
                  </a:solidFill>
                  <a:latin typeface="Arial"/>
                </a:rPr>
                <a:t>1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3981600" y="394632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ff3300"/>
                  </a:solidFill>
                  <a:latin typeface="Arial"/>
                </a:rPr>
                <a:t>23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3981600" y="409896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ff3300"/>
                  </a:solidFill>
                  <a:latin typeface="Arial"/>
                </a:rPr>
                <a:t>184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3981600" y="425124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ff3300"/>
                  </a:solidFill>
                  <a:latin typeface="Arial"/>
                </a:rPr>
                <a:t>13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3981600" y="440352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ff3300"/>
                  </a:solidFill>
                  <a:latin typeface="Arial"/>
                </a:rPr>
                <a:t>22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3981600" y="455616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ff3300"/>
                  </a:solidFill>
                  <a:latin typeface="Arial"/>
                </a:rPr>
                <a:t>13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3981600" y="470844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ff3300"/>
                  </a:solidFill>
                  <a:latin typeface="Arial"/>
                </a:rPr>
                <a:t>16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4057920" y="3336840"/>
              <a:ext cx="0" cy="1523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68" name=""/>
          <p:cNvSpPr/>
          <p:nvPr/>
        </p:nvSpPr>
        <p:spPr>
          <a:xfrm>
            <a:off x="3828960" y="493704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L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"/>
          <p:cNvSpPr/>
          <p:nvPr/>
        </p:nvSpPr>
        <p:spPr>
          <a:xfrm>
            <a:off x="3753000" y="333684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3333cc"/>
                </a:solidFill>
                <a:latin typeface="Arial"/>
              </a:rPr>
              <a:t>17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"/>
          <p:cNvSpPr/>
          <p:nvPr/>
        </p:nvSpPr>
        <p:spPr>
          <a:xfrm>
            <a:off x="3753000" y="348948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33cc"/>
                </a:solidFill>
                <a:latin typeface="Arial"/>
              </a:rPr>
              <a:t>15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"/>
          <p:cNvSpPr/>
          <p:nvPr/>
        </p:nvSpPr>
        <p:spPr>
          <a:xfrm>
            <a:off x="3753000" y="364176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3333cc"/>
                </a:solidFill>
                <a:latin typeface="Arial"/>
              </a:rPr>
              <a:t>14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"/>
          <p:cNvSpPr/>
          <p:nvPr/>
        </p:nvSpPr>
        <p:spPr>
          <a:xfrm>
            <a:off x="3753000" y="379404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3333cc"/>
                </a:solidFill>
                <a:latin typeface="Arial"/>
              </a:rPr>
              <a:t>16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"/>
          <p:cNvSpPr/>
          <p:nvPr/>
        </p:nvSpPr>
        <p:spPr>
          <a:xfrm>
            <a:off x="3753000" y="394668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33cc"/>
                </a:solidFill>
                <a:latin typeface="Arial"/>
              </a:rPr>
              <a:t>23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"/>
          <p:cNvSpPr/>
          <p:nvPr/>
        </p:nvSpPr>
        <p:spPr>
          <a:xfrm>
            <a:off x="3753000" y="409896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3333cc"/>
                </a:solidFill>
                <a:latin typeface="Arial"/>
              </a:rPr>
              <a:t>179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"/>
          <p:cNvSpPr/>
          <p:nvPr/>
        </p:nvSpPr>
        <p:spPr>
          <a:xfrm>
            <a:off x="3753000" y="425124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33cc"/>
                </a:solidFill>
                <a:latin typeface="Arial"/>
              </a:rPr>
              <a:t>13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"/>
          <p:cNvSpPr/>
          <p:nvPr/>
        </p:nvSpPr>
        <p:spPr>
          <a:xfrm>
            <a:off x="3753000" y="440388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33cc"/>
                </a:solidFill>
                <a:latin typeface="Arial"/>
              </a:rPr>
              <a:t>22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"/>
          <p:cNvSpPr/>
          <p:nvPr/>
        </p:nvSpPr>
        <p:spPr>
          <a:xfrm>
            <a:off x="3753000" y="455616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3333cc"/>
                </a:solidFill>
                <a:latin typeface="Arial"/>
              </a:rPr>
              <a:t>14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"/>
          <p:cNvSpPr/>
          <p:nvPr/>
        </p:nvSpPr>
        <p:spPr>
          <a:xfrm>
            <a:off x="3753000" y="470844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3333cc"/>
                </a:solidFill>
                <a:latin typeface="Arial"/>
              </a:rPr>
              <a:t>16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"/>
          <p:cNvSpPr/>
          <p:nvPr/>
        </p:nvSpPr>
        <p:spPr>
          <a:xfrm>
            <a:off x="304920" y="716040"/>
            <a:ext cx="335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URE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80" name=""/>
          <p:cNvGrpSpPr/>
          <p:nvPr/>
        </p:nvGrpSpPr>
        <p:grpSpPr>
          <a:xfrm>
            <a:off x="7620120" y="2041560"/>
            <a:ext cx="1371600" cy="1846440"/>
            <a:chOff x="7620120" y="2041560"/>
            <a:chExt cx="1371600" cy="1846440"/>
          </a:xfrm>
        </p:grpSpPr>
        <p:grpSp>
          <p:nvGrpSpPr>
            <p:cNvPr id="181" name=""/>
            <p:cNvGrpSpPr/>
            <p:nvPr/>
          </p:nvGrpSpPr>
          <p:grpSpPr>
            <a:xfrm>
              <a:off x="7620120" y="2041560"/>
              <a:ext cx="685800" cy="1236960"/>
              <a:chOff x="7620120" y="2041560"/>
              <a:chExt cx="685800" cy="1236960"/>
            </a:xfrm>
          </p:grpSpPr>
          <p:sp>
            <p:nvSpPr>
              <p:cNvPr id="182" name=""/>
              <p:cNvSpPr/>
              <p:nvPr/>
            </p:nvSpPr>
            <p:spPr>
              <a:xfrm>
                <a:off x="7696440" y="2041560"/>
                <a:ext cx="0" cy="914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7620120" y="204156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D11S418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7620120" y="219384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D11S235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7620120" y="234648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</a:rPr>
                  <a:t>D11S187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7620120" y="249876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</a:rPr>
                  <a:t>D11S489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7620120" y="265104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</a:rPr>
                  <a:t>D11S17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7620120" y="280368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D11S133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7696440" y="3032280"/>
                <a:ext cx="533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BB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90" name=""/>
            <p:cNvGrpSpPr/>
            <p:nvPr/>
          </p:nvGrpSpPr>
          <p:grpSpPr>
            <a:xfrm>
              <a:off x="8305920" y="2041560"/>
              <a:ext cx="685800" cy="1846440"/>
              <a:chOff x="8305920" y="2041560"/>
              <a:chExt cx="685800" cy="1846440"/>
            </a:xfrm>
          </p:grpSpPr>
          <p:sp>
            <p:nvSpPr>
              <p:cNvPr id="191" name=""/>
              <p:cNvSpPr/>
              <p:nvPr/>
            </p:nvSpPr>
            <p:spPr>
              <a:xfrm>
                <a:off x="8305920" y="204156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</a:rPr>
                  <a:t>D6S157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8305920" y="219420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D6S12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8305920" y="234648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</a:rPr>
                  <a:t>MOG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8305920" y="249876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</a:rPr>
                  <a:t>D6S244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8305920" y="265140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D6S15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8305920" y="280368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</a:rPr>
                  <a:t>D6S158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8305920" y="295596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D6S161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8305920" y="310860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D6S161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8305920" y="326088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</a:rPr>
                  <a:t>D6S16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8305920" y="3413160"/>
                <a:ext cx="685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D6S155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8382240" y="2041560"/>
                <a:ext cx="0" cy="1524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8382240" y="3641760"/>
                <a:ext cx="4572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LA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28T18:18:30Z</dcterms:created>
  <dc:creator>Administrador</dc:creator>
  <dc:description/>
  <dc:language>en-US</dc:language>
  <cp:lastModifiedBy>Administrador</cp:lastModifiedBy>
  <dcterms:modified xsi:type="dcterms:W3CDTF">2013-01-21T13:23:57Z</dcterms:modified>
  <cp:revision>23</cp:revision>
  <dc:subject/>
  <dc:title>Presentación de PowerPoint</dc:title>
</cp:coreProperties>
</file>